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BA021693-672F-4B0A-AC7A-AC92F3D1C1B9}"/>
              </a:ext>
            </a:extLst>
          </p:cNvPr>
          <p:cNvGrpSpPr/>
          <p:nvPr/>
        </p:nvGrpSpPr>
        <p:grpSpPr>
          <a:xfrm>
            <a:off x="2371498" y="3011273"/>
            <a:ext cx="3486323" cy="1206699"/>
            <a:chOff x="-11215" y="6806437"/>
            <a:chExt cx="6197906" cy="2145237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926A417-938E-C38E-1C31-4C7AC25E2DDB}"/>
                </a:ext>
              </a:extLst>
            </p:cNvPr>
            <p:cNvSpPr txBox="1"/>
            <p:nvPr/>
          </p:nvSpPr>
          <p:spPr>
            <a:xfrm>
              <a:off x="3465568" y="6806437"/>
              <a:ext cx="2209526" cy="437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-log10(p-value)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F460071A-7372-3CC4-20AF-946FE6D27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1215" y="7244162"/>
              <a:ext cx="6197906" cy="1707512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57888A8-79A8-6DCA-7C76-AB8667E8CD1D}"/>
                </a:ext>
              </a:extLst>
            </p:cNvPr>
            <p:cNvSpPr txBox="1"/>
            <p:nvPr/>
          </p:nvSpPr>
          <p:spPr>
            <a:xfrm>
              <a:off x="4445" y="7264318"/>
              <a:ext cx="1059207" cy="4924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TC32</a:t>
              </a:r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0852519A-E555-0747-6468-327B59998D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1498" y="1964116"/>
            <a:ext cx="3528708" cy="96047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E7761A25-9F33-4B9A-FEE0-E66C4B7D832B}"/>
              </a:ext>
            </a:extLst>
          </p:cNvPr>
          <p:cNvSpPr txBox="1"/>
          <p:nvPr/>
        </p:nvSpPr>
        <p:spPr>
          <a:xfrm>
            <a:off x="2380307" y="1964938"/>
            <a:ext cx="59580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430EEF2-9AFC-7CA8-447A-1111981B62BF}"/>
              </a:ext>
            </a:extLst>
          </p:cNvPr>
          <p:cNvSpPr txBox="1"/>
          <p:nvPr/>
        </p:nvSpPr>
        <p:spPr>
          <a:xfrm>
            <a:off x="4369574" y="1756024"/>
            <a:ext cx="1154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-log10(p-value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FEB1BEC-1F84-CF7C-65C2-1E7CD703ECE5}"/>
              </a:ext>
            </a:extLst>
          </p:cNvPr>
          <p:cNvSpPr txBox="1"/>
          <p:nvPr/>
        </p:nvSpPr>
        <p:spPr>
          <a:xfrm>
            <a:off x="286519" y="2672565"/>
            <a:ext cx="1601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Upregulated pathways post RT in hu-CD34+ model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88D65B35-E461-18CF-B34D-ACE42E1DA430}"/>
              </a:ext>
            </a:extLst>
          </p:cNvPr>
          <p:cNvCxnSpPr>
            <a:cxnSpLocks/>
          </p:cNvCxnSpPr>
          <p:nvPr/>
        </p:nvCxnSpPr>
        <p:spPr>
          <a:xfrm flipV="1">
            <a:off x="1846430" y="2729465"/>
            <a:ext cx="281231" cy="1623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4B8E518D-C1C4-C0DF-6D2D-0795B9704F5B}"/>
              </a:ext>
            </a:extLst>
          </p:cNvPr>
          <p:cNvCxnSpPr>
            <a:cxnSpLocks/>
          </p:cNvCxnSpPr>
          <p:nvPr/>
        </p:nvCxnSpPr>
        <p:spPr>
          <a:xfrm>
            <a:off x="1888428" y="3223072"/>
            <a:ext cx="312053" cy="958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01C35CA-9EAE-60BB-A809-275EE130BE23}"/>
              </a:ext>
            </a:extLst>
          </p:cNvPr>
          <p:cNvSpPr txBox="1"/>
          <p:nvPr/>
        </p:nvSpPr>
        <p:spPr>
          <a:xfrm>
            <a:off x="127533" y="4691582"/>
            <a:ext cx="659892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3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Radiation therapy induces upregulation of inflammatory pathways in Ewing sarcoma tumors developed in a hu-CD34+ mouse model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athway analysis was performed utilizing </a:t>
            </a:r>
            <a:r>
              <a:rPr lang="en-US" sz="11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nrichR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ioplanet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2019 on significantly differentially upregulated genes following radiation therapy of tumors developed in hu-CD34+ mice demonstrating upregulation of pathways involved in inflammatory response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4504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2:11Z</dcterms:modified>
</cp:coreProperties>
</file>